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09"/>
  </p:normalViewPr>
  <p:slideViewPr>
    <p:cSldViewPr showGuides="1">
      <p:cViewPr varScale="1">
        <p:scale>
          <a:sx n="92" d="100"/>
          <a:sy n="92" d="100"/>
        </p:scale>
        <p:origin x="166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Στυλ κύριου υπότιτλ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97794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01138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06862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40104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44993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6643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8450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4103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11828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08491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38775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E2C15-54A5-48A3-959C-6006ED9C9131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42E4B-BC7D-4901-88B0-EB7BB2C1B26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19489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292080" y="890432"/>
            <a:ext cx="198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l-G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2000" y="5868000"/>
            <a:ext cx="86306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/>
              <a:t>Figure S6. </a:t>
            </a:r>
            <a:r>
              <a:rPr lang="en-US" dirty="0"/>
              <a:t>BRIG comparison of </a:t>
            </a:r>
            <a:r>
              <a:rPr lang="en-US" dirty="0" err="1"/>
              <a:t>multireplicon</a:t>
            </a:r>
            <a:r>
              <a:rPr lang="en-US" dirty="0"/>
              <a:t> KPC-encoding plasmids p51483_KPC (a) and p51069_KPC (b)characterized from </a:t>
            </a:r>
            <a:r>
              <a:rPr lang="en-US" i="1" dirty="0" err="1"/>
              <a:t>Enterobacterales</a:t>
            </a:r>
            <a:r>
              <a:rPr lang="en-US" dirty="0"/>
              <a:t> isolates recovered from Czech hospitals.</a:t>
            </a:r>
            <a:endParaRPr lang="el-GR" dirty="0"/>
          </a:p>
        </p:txBody>
      </p:sp>
      <p:pic>
        <p:nvPicPr>
          <p:cNvPr id="2" name="Εικόνα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8024" y="1404000"/>
            <a:ext cx="4320000" cy="4049433"/>
          </a:xfrm>
          <a:prstGeom prst="rect">
            <a:avLst/>
          </a:prstGeom>
        </p:spPr>
      </p:pic>
      <p:pic>
        <p:nvPicPr>
          <p:cNvPr id="3" name="Εικόνα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" y="1080000"/>
            <a:ext cx="4860000" cy="471412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61782" y="890284"/>
            <a:ext cx="198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l-G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1573502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37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biochem1</dc:creator>
  <cp:lastModifiedBy>ibrahim bitar</cp:lastModifiedBy>
  <cp:revision>6</cp:revision>
  <dcterms:created xsi:type="dcterms:W3CDTF">2021-03-26T10:18:25Z</dcterms:created>
  <dcterms:modified xsi:type="dcterms:W3CDTF">2021-04-29T08:24:17Z</dcterms:modified>
</cp:coreProperties>
</file>